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1" r:id="rId2"/>
    <p:sldId id="319" r:id="rId3"/>
    <p:sldId id="258" r:id="rId4"/>
    <p:sldId id="311" r:id="rId5"/>
    <p:sldId id="322" r:id="rId6"/>
    <p:sldId id="323" r:id="rId7"/>
    <p:sldId id="314" r:id="rId8"/>
    <p:sldId id="324" r:id="rId9"/>
    <p:sldId id="325" r:id="rId10"/>
    <p:sldId id="326" r:id="rId11"/>
    <p:sldId id="318" r:id="rId12"/>
    <p:sldId id="327" r:id="rId13"/>
    <p:sldId id="306" r:id="rId1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72" y="8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FDA320-98B3-4F34-9C4C-602EB4803B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4E81176-D489-41E4-A6DF-5CB7BE0FE4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1110AA-ECC6-447C-8982-7579DAF11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8A6B1C-8CBA-4793-BF9A-707513E87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BD99F71-8FEE-4401-8247-F8946A743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87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82F6DD-9FCB-4CD9-B794-D980A15BA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241CBDD-AB47-4CAF-95EC-AD0ABFEA5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CCE7E5-AC8F-44CB-8BB4-7B94061CE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B72CA0-1390-488A-BE58-7D96F47F4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2176C6-7CC2-4655-B709-1D0FB8E6F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577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B513390-395A-46B4-9437-9077A2921C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5203DDB-7B35-4813-9722-91E6F75D6B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08D66B-1602-4867-AB5E-4027782E4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EFAC16-8A7F-435B-8101-FFB57A6F3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0D644DA-3249-4A8D-A9F5-49235E659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155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FDD38A-8973-4179-A34E-F06CD210A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0D32A4B-80FC-49D7-8650-B118C6F587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D07807-2545-4988-9575-982FD3108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844EBF-EDBF-4C82-9143-19A307332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13CEA8-8617-4938-B98D-F97B8C20E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67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BB3323B-3F55-4E2E-9AB9-F0B24D092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B4EEF9E-22E6-4850-9864-197F611DE7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E3BE01D-2612-4EC9-9456-8CADAF29B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AA4722-2155-4651-9EBD-E293A73CA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5497A6-2003-4896-A974-15D8AE62D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631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94F5AF-43C9-41A7-8D82-83EBC513E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4AB95E3-6FF0-43C1-86E9-B891626C7A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29A9113-99E9-46D6-A26E-005B4709B4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3F4352D-42FB-494E-872F-C7262A190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3CC9448-8874-4FD5-8ED1-9A1E3E8F4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688653-5FFD-4944-9DEE-EB1FF12AD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6548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A83D7E-04E0-438F-98DD-D111D3354D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71FE993-5EF9-4B1C-BE45-861C8F83D3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190B824-896D-4BA5-AC4C-5B417D1C49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C41181D-5A23-477C-B4F0-6266826BFD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215720D-C9E1-4FF6-9121-7299406EF1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93E38D5-D0E5-4B43-9C85-3725B8399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B077603-67E0-4E7F-AFD9-BAECF2559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9CBA53F7-0A58-4E2E-A812-229EC7E2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2115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8E0549B-BA52-4673-8A83-E61E73E712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28CBC73-AF53-434B-8BE7-1C226E7AB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A3AA4B9-747E-40DB-AD8D-D42149625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94AF00F-AD1B-4E40-BBAF-267C2A23A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123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B0E98A0-5F18-446A-98B7-09CA978E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FE98483-85AE-4B24-82CA-E5AF66332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AA27AEB-244B-4C3A-9BC7-886FCE422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944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BC5075-8B64-4EF8-ADDE-BE3FD7B7C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2743923-2DEF-4B61-AE97-EF01E7F681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1523EB2-EF4B-4550-BD41-29870D9886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28CF76-F73D-4E12-9D1A-631E10AD9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AFC5331-8143-443F-B344-DDF26CFDC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49E876-300D-4991-BE4E-67D481562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002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E696EA-5982-4A95-AD6A-DEF91D656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B7CFCAF-AEE9-4603-9F18-C2217E069A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F83B072-33DE-4BB9-8627-87F86D793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F58E69-27FD-4B0B-870F-2BAEDA79A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5981944-39B7-491C-8D0A-6DD98DF23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FC19725-3EFB-47A6-A8C1-D0E92E7BB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92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5DFE2B9-678E-4507-A927-6FF44E01F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77A9FD6-6102-41AD-98E8-7DCF6C738C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082E7A-F9CF-441B-964F-843C98EF7C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59097-0A71-492C-A30F-00D7B48F96D1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32D249-4085-47AA-AEF6-4CA66C8339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CD9994-9142-4D50-B947-CF497D6400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672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8E96FF7-2900-4682-B395-B535391025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25492">
            <a:off x="3605339" y="117021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53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699498C6-B2E2-4F72-B2E9-B0DC8C2F8F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47309">
            <a:off x="2907662" y="514350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49894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CA8E8EBB-BC5A-427F-8B98-9BD14F048B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47309">
            <a:off x="2907662" y="514350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06864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05E4D262-CF88-4A16-B7D5-0C5A4EA023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47309">
            <a:off x="2907662" y="514350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57528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그룹 34">
            <a:extLst>
              <a:ext uri="{FF2B5EF4-FFF2-40B4-BE49-F238E27FC236}">
                <a16:creationId xmlns:a16="http://schemas.microsoft.com/office/drawing/2014/main" id="{23DCCD36-ADE5-4175-837A-D90C79E5CD19}"/>
              </a:ext>
            </a:extLst>
          </p:cNvPr>
          <p:cNvGrpSpPr/>
          <p:nvPr/>
        </p:nvGrpSpPr>
        <p:grpSpPr>
          <a:xfrm>
            <a:off x="1864657" y="-184006"/>
            <a:ext cx="8596058" cy="6957825"/>
            <a:chOff x="1864657" y="-184006"/>
            <a:chExt cx="8596058" cy="6957825"/>
          </a:xfrm>
        </p:grpSpPr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C7F8EA03-9CC9-438A-BBF6-14E317681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84771" y="228493"/>
              <a:ext cx="2714625" cy="1628775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5022378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757449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 err="1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 / </a:t>
              </a:r>
              <a:r>
                <a:rPr lang="en-US" altLang="ko-KR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1248324" y="841766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1248323" y="2481637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18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1248324" y="4121508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27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1248324" y="5761378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ouble 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00007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H2B Tag-RFP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직선 연결선 48"/>
            <p:cNvCxnSpPr/>
            <p:nvPr/>
          </p:nvCxnSpPr>
          <p:spPr>
            <a:xfrm>
              <a:off x="2335421" y="339946"/>
              <a:ext cx="777600" cy="8165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7488CEF1-B50F-45F9-8D24-D0A2C04B91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44749" y="228716"/>
              <a:ext cx="2714625" cy="1628775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9634A78C-0705-4E57-98A0-7CB662360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08410" y="228666"/>
              <a:ext cx="2714625" cy="1628775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5CD6D66B-3A5A-4A69-9C78-06C20638F5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744749" y="1867492"/>
              <a:ext cx="2714625" cy="1628775"/>
            </a:xfrm>
            <a:prstGeom prst="rect">
              <a:avLst/>
            </a:prstGeom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61D2F980-71E0-404E-B792-FFF7096C731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84771" y="1867343"/>
              <a:ext cx="2714625" cy="1628775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475C9EB4-BB8B-46C4-BA44-B7E083EDBDA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06065" y="1865429"/>
              <a:ext cx="2714625" cy="1628775"/>
            </a:xfrm>
            <a:prstGeom prst="rect">
              <a:avLst/>
            </a:prstGeom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1FFB944C-C9FF-4B30-8168-09D2B46CB69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746090" y="3506268"/>
              <a:ext cx="2714625" cy="1628775"/>
            </a:xfrm>
            <a:prstGeom prst="rect">
              <a:avLst/>
            </a:prstGeom>
          </p:spPr>
        </p:pic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407C01FA-DEF4-462F-AECC-1264315ECC7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284771" y="3506193"/>
              <a:ext cx="2714625" cy="1628775"/>
            </a:xfrm>
            <a:prstGeom prst="rect">
              <a:avLst/>
            </a:prstGeom>
          </p:spPr>
        </p:pic>
        <p:pic>
          <p:nvPicPr>
            <p:cNvPr id="28" name="그림 27">
              <a:extLst>
                <a:ext uri="{FF2B5EF4-FFF2-40B4-BE49-F238E27FC236}">
                  <a16:creationId xmlns:a16="http://schemas.microsoft.com/office/drawing/2014/main" id="{A6909AEB-7A44-419A-8B04-D55C5BC323C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006064" y="3489492"/>
              <a:ext cx="2714625" cy="1628775"/>
            </a:xfrm>
            <a:prstGeom prst="rect">
              <a:avLst/>
            </a:prstGeom>
          </p:spPr>
        </p:pic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4A182382-29DC-4009-BCC3-7DF44C610BE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744749" y="5145044"/>
              <a:ext cx="2714625" cy="1628775"/>
            </a:xfrm>
            <a:prstGeom prst="rect">
              <a:avLst/>
            </a:prstGeom>
          </p:spPr>
        </p:pic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75B76C91-A8E7-49D2-9007-538F66D34B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284771" y="5145044"/>
              <a:ext cx="2714625" cy="1628775"/>
            </a:xfrm>
            <a:prstGeom prst="rect">
              <a:avLst/>
            </a:prstGeom>
          </p:spPr>
        </p:pic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E7169816-05D3-4562-A288-69BE84114B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017424" y="5143115"/>
              <a:ext cx="2714625" cy="1628775"/>
            </a:xfrm>
            <a:prstGeom prst="rect">
              <a:avLst/>
            </a:prstGeom>
          </p:spPr>
        </p:pic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17D09518-13FF-4BFF-8668-A073D14D32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17424" y="228493"/>
              <a:ext cx="2714625" cy="1628775"/>
            </a:xfrm>
            <a:prstGeom prst="rect">
              <a:avLst/>
            </a:prstGeom>
          </p:spPr>
        </p:pic>
        <p:pic>
          <p:nvPicPr>
            <p:cNvPr id="39" name="그림 38">
              <a:extLst>
                <a:ext uri="{FF2B5EF4-FFF2-40B4-BE49-F238E27FC236}">
                  <a16:creationId xmlns:a16="http://schemas.microsoft.com/office/drawing/2014/main" id="{D08AED43-EDA5-40F0-8309-1493750723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17424" y="1866700"/>
              <a:ext cx="2714625" cy="1628775"/>
            </a:xfrm>
            <a:prstGeom prst="rect">
              <a:avLst/>
            </a:prstGeom>
          </p:spPr>
        </p:pic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879EAF9D-8A05-405C-877A-4D23A92264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017424" y="3504907"/>
              <a:ext cx="2714625" cy="1628775"/>
            </a:xfrm>
            <a:prstGeom prst="rect">
              <a:avLst/>
            </a:prstGeom>
          </p:spPr>
        </p:pic>
        <p:sp>
          <p:nvSpPr>
            <p:cNvPr id="33" name="이등변 삼각형 32">
              <a:extLst>
                <a:ext uri="{FF2B5EF4-FFF2-40B4-BE49-F238E27FC236}">
                  <a16:creationId xmlns:a16="http://schemas.microsoft.com/office/drawing/2014/main" id="{35942593-CBA7-4E22-AF54-F2FD2EDF1E00}"/>
                </a:ext>
              </a:extLst>
            </p:cNvPr>
            <p:cNvSpPr/>
            <p:nvPr/>
          </p:nvSpPr>
          <p:spPr>
            <a:xfrm rot="12310238">
              <a:off x="9141072" y="2700111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이등변 삼각형 40">
              <a:extLst>
                <a:ext uri="{FF2B5EF4-FFF2-40B4-BE49-F238E27FC236}">
                  <a16:creationId xmlns:a16="http://schemas.microsoft.com/office/drawing/2014/main" id="{438C63F5-D24A-4446-BB42-D3492746C6AA}"/>
                </a:ext>
              </a:extLst>
            </p:cNvPr>
            <p:cNvSpPr/>
            <p:nvPr/>
          </p:nvSpPr>
          <p:spPr>
            <a:xfrm rot="12310238">
              <a:off x="10169772" y="2703401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이등변 삼각형 41">
              <a:extLst>
                <a:ext uri="{FF2B5EF4-FFF2-40B4-BE49-F238E27FC236}">
                  <a16:creationId xmlns:a16="http://schemas.microsoft.com/office/drawing/2014/main" id="{62C75B10-46E2-417B-8A27-745C73E84B55}"/>
                </a:ext>
              </a:extLst>
            </p:cNvPr>
            <p:cNvSpPr/>
            <p:nvPr/>
          </p:nvSpPr>
          <p:spPr>
            <a:xfrm rot="12310238">
              <a:off x="9141073" y="236673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이등변 삼각형 42">
              <a:extLst>
                <a:ext uri="{FF2B5EF4-FFF2-40B4-BE49-F238E27FC236}">
                  <a16:creationId xmlns:a16="http://schemas.microsoft.com/office/drawing/2014/main" id="{C1E3283F-D525-48E1-9040-EF7B868A5B36}"/>
                </a:ext>
              </a:extLst>
            </p:cNvPr>
            <p:cNvSpPr/>
            <p:nvPr/>
          </p:nvSpPr>
          <p:spPr>
            <a:xfrm rot="18205534">
              <a:off x="8281071" y="2451408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5" name="이등변 삼각형 44">
              <a:extLst>
                <a:ext uri="{FF2B5EF4-FFF2-40B4-BE49-F238E27FC236}">
                  <a16:creationId xmlns:a16="http://schemas.microsoft.com/office/drawing/2014/main" id="{E73674A7-1096-41D3-89B6-4A6FFB017C20}"/>
                </a:ext>
              </a:extLst>
            </p:cNvPr>
            <p:cNvSpPr/>
            <p:nvPr/>
          </p:nvSpPr>
          <p:spPr>
            <a:xfrm rot="2182958">
              <a:off x="8273460" y="3111387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6" name="이등변 삼각형 45">
              <a:extLst>
                <a:ext uri="{FF2B5EF4-FFF2-40B4-BE49-F238E27FC236}">
                  <a16:creationId xmlns:a16="http://schemas.microsoft.com/office/drawing/2014/main" id="{D9FDB434-B5D7-48A2-8B27-5FAC8373D87A}"/>
                </a:ext>
              </a:extLst>
            </p:cNvPr>
            <p:cNvSpPr/>
            <p:nvPr/>
          </p:nvSpPr>
          <p:spPr>
            <a:xfrm rot="12719220">
              <a:off x="9822109" y="3008706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7" name="이등변 삼각형 46">
              <a:extLst>
                <a:ext uri="{FF2B5EF4-FFF2-40B4-BE49-F238E27FC236}">
                  <a16:creationId xmlns:a16="http://schemas.microsoft.com/office/drawing/2014/main" id="{D40E4B0B-F19A-49F7-BEAD-101D1509199B}"/>
                </a:ext>
              </a:extLst>
            </p:cNvPr>
            <p:cNvSpPr/>
            <p:nvPr/>
          </p:nvSpPr>
          <p:spPr>
            <a:xfrm rot="19331816">
              <a:off x="9417296" y="3068751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이등변 삼각형 47">
              <a:extLst>
                <a:ext uri="{FF2B5EF4-FFF2-40B4-BE49-F238E27FC236}">
                  <a16:creationId xmlns:a16="http://schemas.microsoft.com/office/drawing/2014/main" id="{B8D642C5-3E2E-43EC-A3C2-E305D9F90114}"/>
                </a:ext>
              </a:extLst>
            </p:cNvPr>
            <p:cNvSpPr/>
            <p:nvPr/>
          </p:nvSpPr>
          <p:spPr>
            <a:xfrm>
              <a:off x="9212953" y="3058786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0" name="이등변 삼각형 49">
              <a:extLst>
                <a:ext uri="{FF2B5EF4-FFF2-40B4-BE49-F238E27FC236}">
                  <a16:creationId xmlns:a16="http://schemas.microsoft.com/office/drawing/2014/main" id="{3C0B2BE6-E40A-4837-B7EC-2047AF312AB9}"/>
                </a:ext>
              </a:extLst>
            </p:cNvPr>
            <p:cNvSpPr/>
            <p:nvPr/>
          </p:nvSpPr>
          <p:spPr>
            <a:xfrm rot="1676392">
              <a:off x="8974860" y="3221867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이등변 삼각형 50">
              <a:extLst>
                <a:ext uri="{FF2B5EF4-FFF2-40B4-BE49-F238E27FC236}">
                  <a16:creationId xmlns:a16="http://schemas.microsoft.com/office/drawing/2014/main" id="{C60D6D06-CA5A-4EAF-B091-BB9C54F1BC32}"/>
                </a:ext>
              </a:extLst>
            </p:cNvPr>
            <p:cNvSpPr/>
            <p:nvPr/>
          </p:nvSpPr>
          <p:spPr>
            <a:xfrm rot="11228346">
              <a:off x="8816490" y="2988021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2" name="이등변 삼각형 51">
              <a:extLst>
                <a:ext uri="{FF2B5EF4-FFF2-40B4-BE49-F238E27FC236}">
                  <a16:creationId xmlns:a16="http://schemas.microsoft.com/office/drawing/2014/main" id="{5B212059-A433-4A39-B167-C7375D9DBC56}"/>
                </a:ext>
              </a:extLst>
            </p:cNvPr>
            <p:cNvSpPr/>
            <p:nvPr/>
          </p:nvSpPr>
          <p:spPr>
            <a:xfrm rot="10458313">
              <a:off x="7929490" y="298272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3" name="이등변 삼각형 52">
              <a:extLst>
                <a:ext uri="{FF2B5EF4-FFF2-40B4-BE49-F238E27FC236}">
                  <a16:creationId xmlns:a16="http://schemas.microsoft.com/office/drawing/2014/main" id="{13FDF59E-3571-47FE-B9CF-8C9ACE577834}"/>
                </a:ext>
              </a:extLst>
            </p:cNvPr>
            <p:cNvSpPr/>
            <p:nvPr/>
          </p:nvSpPr>
          <p:spPr>
            <a:xfrm rot="19331816">
              <a:off x="10019091" y="3884726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4" name="이등변 삼각형 53">
              <a:extLst>
                <a:ext uri="{FF2B5EF4-FFF2-40B4-BE49-F238E27FC236}">
                  <a16:creationId xmlns:a16="http://schemas.microsoft.com/office/drawing/2014/main" id="{438EA269-DBB2-4F8A-B045-8C284972CAF2}"/>
                </a:ext>
              </a:extLst>
            </p:cNvPr>
            <p:cNvSpPr/>
            <p:nvPr/>
          </p:nvSpPr>
          <p:spPr>
            <a:xfrm rot="10303607">
              <a:off x="10331076" y="454512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5" name="이등변 삼각형 54">
              <a:extLst>
                <a:ext uri="{FF2B5EF4-FFF2-40B4-BE49-F238E27FC236}">
                  <a16:creationId xmlns:a16="http://schemas.microsoft.com/office/drawing/2014/main" id="{AB4B278A-2B37-4C56-B13F-2DE9A9D4FB04}"/>
                </a:ext>
              </a:extLst>
            </p:cNvPr>
            <p:cNvSpPr/>
            <p:nvPr/>
          </p:nvSpPr>
          <p:spPr>
            <a:xfrm rot="10303607">
              <a:off x="9798743" y="4354330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6" name="이등변 삼각형 55">
              <a:extLst>
                <a:ext uri="{FF2B5EF4-FFF2-40B4-BE49-F238E27FC236}">
                  <a16:creationId xmlns:a16="http://schemas.microsoft.com/office/drawing/2014/main" id="{02FD18A5-9460-4BA1-A728-486AA4DD240A}"/>
                </a:ext>
              </a:extLst>
            </p:cNvPr>
            <p:cNvSpPr/>
            <p:nvPr/>
          </p:nvSpPr>
          <p:spPr>
            <a:xfrm rot="19509984">
              <a:off x="9539786" y="462648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7" name="이등변 삼각형 56">
              <a:extLst>
                <a:ext uri="{FF2B5EF4-FFF2-40B4-BE49-F238E27FC236}">
                  <a16:creationId xmlns:a16="http://schemas.microsoft.com/office/drawing/2014/main" id="{1E82E437-984E-4BFD-983F-A28FE36AA369}"/>
                </a:ext>
              </a:extLst>
            </p:cNvPr>
            <p:cNvSpPr/>
            <p:nvPr/>
          </p:nvSpPr>
          <p:spPr>
            <a:xfrm rot="10303607">
              <a:off x="8867917" y="428892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8" name="이등변 삼각형 57">
              <a:extLst>
                <a:ext uri="{FF2B5EF4-FFF2-40B4-BE49-F238E27FC236}">
                  <a16:creationId xmlns:a16="http://schemas.microsoft.com/office/drawing/2014/main" id="{D4118270-C0EF-458B-BDAE-3449F2B2AC5D}"/>
                </a:ext>
              </a:extLst>
            </p:cNvPr>
            <p:cNvSpPr/>
            <p:nvPr/>
          </p:nvSpPr>
          <p:spPr>
            <a:xfrm rot="18917207">
              <a:off x="10033379" y="479689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9" name="이등변 삼각형 58">
              <a:extLst>
                <a:ext uri="{FF2B5EF4-FFF2-40B4-BE49-F238E27FC236}">
                  <a16:creationId xmlns:a16="http://schemas.microsoft.com/office/drawing/2014/main" id="{5DAA8E62-37E5-4E93-BBB3-695D37F527CF}"/>
                </a:ext>
              </a:extLst>
            </p:cNvPr>
            <p:cNvSpPr/>
            <p:nvPr/>
          </p:nvSpPr>
          <p:spPr>
            <a:xfrm rot="10303607">
              <a:off x="8450799" y="4354330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0" name="이등변 삼각형 59">
              <a:extLst>
                <a:ext uri="{FF2B5EF4-FFF2-40B4-BE49-F238E27FC236}">
                  <a16:creationId xmlns:a16="http://schemas.microsoft.com/office/drawing/2014/main" id="{21166503-6B99-4902-9706-E6BBC30D99F4}"/>
                </a:ext>
              </a:extLst>
            </p:cNvPr>
            <p:cNvSpPr/>
            <p:nvPr/>
          </p:nvSpPr>
          <p:spPr>
            <a:xfrm rot="10303607">
              <a:off x="7909015" y="424149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1" name="이등변 삼각형 60">
              <a:extLst>
                <a:ext uri="{FF2B5EF4-FFF2-40B4-BE49-F238E27FC236}">
                  <a16:creationId xmlns:a16="http://schemas.microsoft.com/office/drawing/2014/main" id="{B557D28F-6EA4-436B-BA7B-3C5FA680EA39}"/>
                </a:ext>
              </a:extLst>
            </p:cNvPr>
            <p:cNvSpPr/>
            <p:nvPr/>
          </p:nvSpPr>
          <p:spPr>
            <a:xfrm rot="18680093">
              <a:off x="8064180" y="4877021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2" name="이등변 삼각형 61">
              <a:extLst>
                <a:ext uri="{FF2B5EF4-FFF2-40B4-BE49-F238E27FC236}">
                  <a16:creationId xmlns:a16="http://schemas.microsoft.com/office/drawing/2014/main" id="{E467BF7E-3174-43EB-A33E-CEB6092E008C}"/>
                </a:ext>
              </a:extLst>
            </p:cNvPr>
            <p:cNvSpPr/>
            <p:nvPr/>
          </p:nvSpPr>
          <p:spPr>
            <a:xfrm rot="18017053">
              <a:off x="8251690" y="4687080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3" name="이등변 삼각형 62">
              <a:extLst>
                <a:ext uri="{FF2B5EF4-FFF2-40B4-BE49-F238E27FC236}">
                  <a16:creationId xmlns:a16="http://schemas.microsoft.com/office/drawing/2014/main" id="{F8AAB047-0ACD-4280-ACDA-95A2B242A07C}"/>
                </a:ext>
              </a:extLst>
            </p:cNvPr>
            <p:cNvSpPr/>
            <p:nvPr/>
          </p:nvSpPr>
          <p:spPr>
            <a:xfrm rot="14033945">
              <a:off x="8920722" y="4652306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4" name="이등변 삼각형 63">
              <a:extLst>
                <a:ext uri="{FF2B5EF4-FFF2-40B4-BE49-F238E27FC236}">
                  <a16:creationId xmlns:a16="http://schemas.microsoft.com/office/drawing/2014/main" id="{095EFD91-10A2-4FC6-9B5B-7D4554562C30}"/>
                </a:ext>
              </a:extLst>
            </p:cNvPr>
            <p:cNvSpPr/>
            <p:nvPr/>
          </p:nvSpPr>
          <p:spPr>
            <a:xfrm rot="10303607">
              <a:off x="10222578" y="5962797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5" name="이등변 삼각형 64">
              <a:extLst>
                <a:ext uri="{FF2B5EF4-FFF2-40B4-BE49-F238E27FC236}">
                  <a16:creationId xmlns:a16="http://schemas.microsoft.com/office/drawing/2014/main" id="{DF82895D-E6DE-473D-96F4-F6D3C166EEB4}"/>
                </a:ext>
              </a:extLst>
            </p:cNvPr>
            <p:cNvSpPr/>
            <p:nvPr/>
          </p:nvSpPr>
          <p:spPr>
            <a:xfrm rot="11230227">
              <a:off x="10331076" y="626573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6" name="이등변 삼각형 65">
              <a:extLst>
                <a:ext uri="{FF2B5EF4-FFF2-40B4-BE49-F238E27FC236}">
                  <a16:creationId xmlns:a16="http://schemas.microsoft.com/office/drawing/2014/main" id="{BC119BC9-BCF1-42BF-96F3-2CD6598C1DD8}"/>
                </a:ext>
              </a:extLst>
            </p:cNvPr>
            <p:cNvSpPr/>
            <p:nvPr/>
          </p:nvSpPr>
          <p:spPr>
            <a:xfrm rot="10303607">
              <a:off x="8846302" y="5937700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7" name="이등변 삼각형 66">
              <a:extLst>
                <a:ext uri="{FF2B5EF4-FFF2-40B4-BE49-F238E27FC236}">
                  <a16:creationId xmlns:a16="http://schemas.microsoft.com/office/drawing/2014/main" id="{46AE8BCC-985E-4936-A7E6-67F289398ACE}"/>
                </a:ext>
              </a:extLst>
            </p:cNvPr>
            <p:cNvSpPr/>
            <p:nvPr/>
          </p:nvSpPr>
          <p:spPr>
            <a:xfrm rot="12921445">
              <a:off x="8184093" y="5927784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8" name="이등변 삼각형 67">
              <a:extLst>
                <a:ext uri="{FF2B5EF4-FFF2-40B4-BE49-F238E27FC236}">
                  <a16:creationId xmlns:a16="http://schemas.microsoft.com/office/drawing/2014/main" id="{C2A07B9F-BA8D-48B1-9412-2B4F71357FFA}"/>
                </a:ext>
              </a:extLst>
            </p:cNvPr>
            <p:cNvSpPr/>
            <p:nvPr/>
          </p:nvSpPr>
          <p:spPr>
            <a:xfrm rot="10303607">
              <a:off x="7826362" y="5890274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9" name="이등변 삼각형 68">
              <a:extLst>
                <a:ext uri="{FF2B5EF4-FFF2-40B4-BE49-F238E27FC236}">
                  <a16:creationId xmlns:a16="http://schemas.microsoft.com/office/drawing/2014/main" id="{F5CE240A-C782-41E8-90BA-EC49B843A375}"/>
                </a:ext>
              </a:extLst>
            </p:cNvPr>
            <p:cNvSpPr/>
            <p:nvPr/>
          </p:nvSpPr>
          <p:spPr>
            <a:xfrm rot="20178102">
              <a:off x="8725550" y="6392997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0" name="이등변 삼각형 69">
              <a:extLst>
                <a:ext uri="{FF2B5EF4-FFF2-40B4-BE49-F238E27FC236}">
                  <a16:creationId xmlns:a16="http://schemas.microsoft.com/office/drawing/2014/main" id="{F0C6819D-E473-4895-ADA0-5085A678FEBF}"/>
                </a:ext>
              </a:extLst>
            </p:cNvPr>
            <p:cNvSpPr/>
            <p:nvPr/>
          </p:nvSpPr>
          <p:spPr>
            <a:xfrm rot="13507687">
              <a:off x="8357209" y="616703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1" name="이등변 삼각형 70">
              <a:extLst>
                <a:ext uri="{FF2B5EF4-FFF2-40B4-BE49-F238E27FC236}">
                  <a16:creationId xmlns:a16="http://schemas.microsoft.com/office/drawing/2014/main" id="{62C3A453-5F32-4656-B082-439B75216A5E}"/>
                </a:ext>
              </a:extLst>
            </p:cNvPr>
            <p:cNvSpPr/>
            <p:nvPr/>
          </p:nvSpPr>
          <p:spPr>
            <a:xfrm rot="2314452">
              <a:off x="8509609" y="6319433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2" name="이등변 삼각형 71">
              <a:extLst>
                <a:ext uri="{FF2B5EF4-FFF2-40B4-BE49-F238E27FC236}">
                  <a16:creationId xmlns:a16="http://schemas.microsoft.com/office/drawing/2014/main" id="{886B2D7A-9C76-400F-ABB7-7004A90AA0D9}"/>
                </a:ext>
              </a:extLst>
            </p:cNvPr>
            <p:cNvSpPr/>
            <p:nvPr/>
          </p:nvSpPr>
          <p:spPr>
            <a:xfrm rot="19337232">
              <a:off x="9162977" y="6519900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3" name="이등변 삼각형 72">
              <a:extLst>
                <a:ext uri="{FF2B5EF4-FFF2-40B4-BE49-F238E27FC236}">
                  <a16:creationId xmlns:a16="http://schemas.microsoft.com/office/drawing/2014/main" id="{47916DC9-4E20-4637-995C-696E0452B621}"/>
                </a:ext>
              </a:extLst>
            </p:cNvPr>
            <p:cNvSpPr/>
            <p:nvPr/>
          </p:nvSpPr>
          <p:spPr>
            <a:xfrm rot="3975655">
              <a:off x="9951584" y="6503194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4" name="이등변 삼각형 73">
              <a:extLst>
                <a:ext uri="{FF2B5EF4-FFF2-40B4-BE49-F238E27FC236}">
                  <a16:creationId xmlns:a16="http://schemas.microsoft.com/office/drawing/2014/main" id="{B057F2A6-E4B9-425A-8211-75AC4805DBB9}"/>
                </a:ext>
              </a:extLst>
            </p:cNvPr>
            <p:cNvSpPr/>
            <p:nvPr/>
          </p:nvSpPr>
          <p:spPr>
            <a:xfrm rot="9577873">
              <a:off x="8724531" y="602151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5" name="이등변 삼각형 74">
              <a:extLst>
                <a:ext uri="{FF2B5EF4-FFF2-40B4-BE49-F238E27FC236}">
                  <a16:creationId xmlns:a16="http://schemas.microsoft.com/office/drawing/2014/main" id="{34210497-ABDF-4BAA-97DF-4520E1BD107D}"/>
                </a:ext>
              </a:extLst>
            </p:cNvPr>
            <p:cNvSpPr/>
            <p:nvPr/>
          </p:nvSpPr>
          <p:spPr>
            <a:xfrm rot="13507687">
              <a:off x="9377868" y="6069745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6" name="이등변 삼각형 75">
              <a:extLst>
                <a:ext uri="{FF2B5EF4-FFF2-40B4-BE49-F238E27FC236}">
                  <a16:creationId xmlns:a16="http://schemas.microsoft.com/office/drawing/2014/main" id="{03A08B27-9D2A-408A-A89B-BE09EBE3C376}"/>
                </a:ext>
              </a:extLst>
            </p:cNvPr>
            <p:cNvSpPr/>
            <p:nvPr/>
          </p:nvSpPr>
          <p:spPr>
            <a:xfrm rot="17922556">
              <a:off x="9531098" y="6510604"/>
              <a:ext cx="84601" cy="152126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887965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0616DED4-2B3A-447A-97C0-7AD1AC0CA8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37709">
            <a:off x="3606496" y="118177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6866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8E96FF7-2900-4682-B395-B535391025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25492">
            <a:off x="3605339" y="117021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0616DED4-2B3A-447A-97C0-7AD1AC0CA8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437709">
            <a:off x="3606496" y="118177"/>
            <a:ext cx="5905500" cy="59055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AEBC0694-9E09-41E1-BB32-98C2CC7569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440434">
            <a:off x="3605090" y="118426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8623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E8E49310-B7FF-41FD-8233-7840EA2CE2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03904">
            <a:off x="3879852" y="476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43845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866F3206-A544-4BA2-97F4-8D5B3A0D4F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03904">
            <a:off x="3879852" y="476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71061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B9B71478-7D90-4B70-89FE-965FA69A44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03904">
            <a:off x="3879852" y="476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40464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2B1B295D-CB8B-4AA7-AB4C-77DD7D1227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97374">
            <a:off x="3663949" y="95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2074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ECC4A0F-26A3-4347-9619-06B570EA0A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97374">
            <a:off x="3663949" y="95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23141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62C80105-5B86-47FD-88FA-A4569D297F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97374">
            <a:off x="3663949" y="95249"/>
            <a:ext cx="5905500" cy="5905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6282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47</Words>
  <Application>Microsoft Office PowerPoint</Application>
  <PresentationFormat>와이드스크린</PresentationFormat>
  <Paragraphs>19</Paragraphs>
  <Slides>1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1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8</cp:revision>
  <dcterms:created xsi:type="dcterms:W3CDTF">2019-06-12T05:13:05Z</dcterms:created>
  <dcterms:modified xsi:type="dcterms:W3CDTF">2024-09-27T02:44:22Z</dcterms:modified>
</cp:coreProperties>
</file>